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211638" cy="4737100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1A69A-3F8F-4833-B973-8ED4AF1FB2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210600" y="1106280"/>
            <a:ext cx="37897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210600" y="2739960"/>
            <a:ext cx="37897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FF4AE-7083-41EB-90E6-CFB17A956A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210600" y="1106280"/>
            <a:ext cx="18493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2152800" y="1106280"/>
            <a:ext cx="18493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210600" y="2739960"/>
            <a:ext cx="18493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2152800" y="2739960"/>
            <a:ext cx="18493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6E43DA-C55D-4381-9789-7EB716C054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210600" y="1106280"/>
            <a:ext cx="122004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1492200" y="1106280"/>
            <a:ext cx="122004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2773440" y="1106280"/>
            <a:ext cx="122004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210600" y="2739960"/>
            <a:ext cx="122004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1492200" y="2739960"/>
            <a:ext cx="122004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2773440" y="2739960"/>
            <a:ext cx="122004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74C427-24BE-48B1-9A1F-55F5BCA232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210600" y="1106280"/>
            <a:ext cx="3789720" cy="3127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126715-361B-424A-B2E5-1F763AD0A7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210600" y="1106280"/>
            <a:ext cx="3789720" cy="31273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04973-14F6-45F2-8A66-660572602E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210600" y="1106280"/>
            <a:ext cx="1849320" cy="31273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2152800" y="1106280"/>
            <a:ext cx="1849320" cy="31273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5680D7-B1F0-46CA-8D05-16708D0278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8184B-8873-4C72-B4C2-8A90B0D39C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210600" y="190440"/>
            <a:ext cx="3789720" cy="365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99"/>
              </a:spcBef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9EBC2-59D2-47ED-A6CA-B91BA02341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210600" y="1106280"/>
            <a:ext cx="18493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2152800" y="1106280"/>
            <a:ext cx="1849320" cy="31273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210600" y="2739960"/>
            <a:ext cx="18493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67DE80-5497-4D5A-AE57-EA061959A6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210600" y="1106280"/>
            <a:ext cx="1849320" cy="31273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2152800" y="1106280"/>
            <a:ext cx="18493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2152800" y="2739960"/>
            <a:ext cx="18493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12D2C-9FF3-48C6-9D74-AFACE344B9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210600" y="1106280"/>
            <a:ext cx="18493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2152800" y="1106280"/>
            <a:ext cx="18493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210600" y="2739960"/>
            <a:ext cx="3789720" cy="14914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48FFEF-A168-46B6-8F88-BEC0DE0959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10600" y="190440"/>
            <a:ext cx="3789720" cy="7891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ctr">
            <a:noAutofit/>
          </a:bodyPr>
          <a:p>
            <a:pPr indent="0" algn="ctr">
              <a:buNone/>
              <a:tabLst>
                <a:tab algn="l" pos="0"/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10600" y="1106280"/>
            <a:ext cx="3789720" cy="312732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rmAutofit fontScale="98000"/>
          </a:bodyPr>
          <a:p>
            <a:pPr marL="205200" indent="-20520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446400" indent="-17280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686160" indent="-13680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961200" indent="-13824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234800" indent="-1368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234800" indent="-1368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234800" indent="-1368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0520"/>
                <a:tab algn="l" pos="1120680"/>
                <a:tab algn="l" pos="1681200"/>
                <a:tab algn="l" pos="2241720"/>
                <a:tab algn="l" pos="2801880"/>
                <a:tab algn="l" pos="3362400"/>
                <a:tab algn="l" pos="3922560"/>
                <a:tab algn="l" pos="4483080"/>
                <a:tab algn="l" pos="5043600"/>
                <a:tab algn="l" pos="5603760"/>
                <a:tab algn="l" pos="6164280"/>
                <a:tab algn="l" pos="6724800"/>
                <a:tab algn="l" pos="7284960"/>
                <a:tab algn="l" pos="7845480"/>
                <a:tab algn="l" pos="8405640"/>
                <a:tab algn="l" pos="8966160"/>
                <a:tab algn="l" pos="9526680"/>
                <a:tab algn="l" pos="10086840"/>
                <a:tab algn="l" pos="106473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10960" y="4316400"/>
            <a:ext cx="982800" cy="3268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37840" y="4316400"/>
            <a:ext cx="1335240" cy="3268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017880" y="4316400"/>
            <a:ext cx="982800" cy="326880"/>
          </a:xfrm>
          <a:prstGeom prst="rect">
            <a:avLst/>
          </a:prstGeom>
          <a:noFill/>
          <a:ln w="0">
            <a:noFill/>
          </a:ln>
        </p:spPr>
        <p:txBody>
          <a:bodyPr lIns="56160" rIns="56160" tIns="28080" bIns="2808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93B5A8-1B61-4AB6-B995-5D6ACB93531B}" type="slidenum">
              <a:rPr b="0" lang="en-GB" sz="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Base" hidden="1"/>
          <p:cNvSpPr/>
          <p:nvPr/>
        </p:nvSpPr>
        <p:spPr>
          <a:xfrm>
            <a:off x="701640" y="1433520"/>
            <a:ext cx="2806560" cy="187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AutoShape 1188"/>
          <p:cNvSpPr/>
          <p:nvPr/>
        </p:nvSpPr>
        <p:spPr>
          <a:xfrm>
            <a:off x="-3611520" y="203040"/>
            <a:ext cx="7381800" cy="8786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1189"/>
          <p:cNvSpPr/>
          <p:nvPr/>
        </p:nvSpPr>
        <p:spPr>
          <a:xfrm>
            <a:off x="825480" y="4522680"/>
            <a:ext cx="244440" cy="180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190"/>
          <p:cNvSpPr/>
          <p:nvPr/>
        </p:nvSpPr>
        <p:spPr>
          <a:xfrm>
            <a:off x="904680" y="43387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191"/>
          <p:cNvSpPr/>
          <p:nvPr/>
        </p:nvSpPr>
        <p:spPr>
          <a:xfrm>
            <a:off x="73080" y="3083040"/>
            <a:ext cx="463320" cy="1364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192"/>
          <p:cNvSpPr/>
          <p:nvPr/>
        </p:nvSpPr>
        <p:spPr>
          <a:xfrm>
            <a:off x="298440" y="704880"/>
            <a:ext cx="339840" cy="43956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193"/>
          <p:cNvSpPr/>
          <p:nvPr/>
        </p:nvSpPr>
        <p:spPr>
          <a:xfrm rot="13961400">
            <a:off x="-70920" y="475560"/>
            <a:ext cx="453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latypus TLR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194"/>
          <p:cNvSpPr/>
          <p:nvPr/>
        </p:nvSpPr>
        <p:spPr>
          <a:xfrm>
            <a:off x="530280" y="449280"/>
            <a:ext cx="198360" cy="31284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195"/>
          <p:cNvSpPr/>
          <p:nvPr/>
        </p:nvSpPr>
        <p:spPr>
          <a:xfrm rot="14287200">
            <a:off x="285120" y="272520"/>
            <a:ext cx="30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Bat TLR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196"/>
          <p:cNvSpPr/>
          <p:nvPr/>
        </p:nvSpPr>
        <p:spPr>
          <a:xfrm>
            <a:off x="870120" y="312840"/>
            <a:ext cx="66600" cy="19836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197"/>
          <p:cNvSpPr/>
          <p:nvPr/>
        </p:nvSpPr>
        <p:spPr>
          <a:xfrm rot="15553800">
            <a:off x="785520" y="118080"/>
            <a:ext cx="19116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LR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198"/>
          <p:cNvSpPr/>
          <p:nvPr/>
        </p:nvSpPr>
        <p:spPr>
          <a:xfrm flipH="1">
            <a:off x="936360" y="393840"/>
            <a:ext cx="114120" cy="11736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199"/>
          <p:cNvSpPr/>
          <p:nvPr/>
        </p:nvSpPr>
        <p:spPr>
          <a:xfrm rot="18697800">
            <a:off x="1025640" y="214200"/>
            <a:ext cx="308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1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200"/>
          <p:cNvSpPr/>
          <p:nvPr/>
        </p:nvSpPr>
        <p:spPr>
          <a:xfrm flipH="1">
            <a:off x="728640" y="511200"/>
            <a:ext cx="208080" cy="25092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201"/>
          <p:cNvSpPr/>
          <p:nvPr/>
        </p:nvSpPr>
        <p:spPr>
          <a:xfrm flipH="1">
            <a:off x="637920" y="762120"/>
            <a:ext cx="90360" cy="38232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202"/>
          <p:cNvSpPr/>
          <p:nvPr/>
        </p:nvSpPr>
        <p:spPr>
          <a:xfrm>
            <a:off x="638280" y="1144440"/>
            <a:ext cx="195120" cy="36036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203"/>
          <p:cNvSpPr/>
          <p:nvPr/>
        </p:nvSpPr>
        <p:spPr>
          <a:xfrm flipH="1">
            <a:off x="1193400" y="773280"/>
            <a:ext cx="49320" cy="12672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204"/>
          <p:cNvSpPr/>
          <p:nvPr/>
        </p:nvSpPr>
        <p:spPr>
          <a:xfrm rot="17535000">
            <a:off x="1153800" y="542880"/>
            <a:ext cx="308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1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205"/>
          <p:cNvSpPr/>
          <p:nvPr/>
        </p:nvSpPr>
        <p:spPr>
          <a:xfrm flipH="1">
            <a:off x="1193400" y="820800"/>
            <a:ext cx="128520" cy="7920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1206"/>
          <p:cNvSpPr/>
          <p:nvPr/>
        </p:nvSpPr>
        <p:spPr>
          <a:xfrm rot="18211800">
            <a:off x="1255680" y="592560"/>
            <a:ext cx="399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1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207"/>
          <p:cNvSpPr/>
          <p:nvPr/>
        </p:nvSpPr>
        <p:spPr>
          <a:xfrm flipH="1">
            <a:off x="833040" y="900000"/>
            <a:ext cx="360360" cy="60480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208"/>
          <p:cNvSpPr/>
          <p:nvPr/>
        </p:nvSpPr>
        <p:spPr>
          <a:xfrm>
            <a:off x="833400" y="1504800"/>
            <a:ext cx="87480" cy="72072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209"/>
          <p:cNvSpPr/>
          <p:nvPr/>
        </p:nvSpPr>
        <p:spPr>
          <a:xfrm flipH="1">
            <a:off x="1274400" y="990720"/>
            <a:ext cx="284040" cy="65376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210"/>
          <p:cNvSpPr/>
          <p:nvPr/>
        </p:nvSpPr>
        <p:spPr>
          <a:xfrm rot="18190800">
            <a:off x="1448280" y="68796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1211"/>
          <p:cNvSpPr/>
          <p:nvPr/>
        </p:nvSpPr>
        <p:spPr>
          <a:xfrm flipH="1">
            <a:off x="1274760" y="1052640"/>
            <a:ext cx="566640" cy="59184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212"/>
          <p:cNvSpPr/>
          <p:nvPr/>
        </p:nvSpPr>
        <p:spPr>
          <a:xfrm rot="18306000">
            <a:off x="1761480" y="798840"/>
            <a:ext cx="474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1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1213"/>
          <p:cNvSpPr/>
          <p:nvPr/>
        </p:nvSpPr>
        <p:spPr>
          <a:xfrm flipH="1">
            <a:off x="920520" y="1644480"/>
            <a:ext cx="353880" cy="58104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1214"/>
          <p:cNvSpPr/>
          <p:nvPr/>
        </p:nvSpPr>
        <p:spPr>
          <a:xfrm flipH="1">
            <a:off x="761760" y="2225520"/>
            <a:ext cx="158760" cy="592200"/>
          </a:xfrm>
          <a:prstGeom prst="line">
            <a:avLst/>
          </a:prstGeom>
          <a:ln cap="sq" w="15840">
            <a:solidFill>
              <a:srgbClr val="ff99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1215"/>
          <p:cNvSpPr/>
          <p:nvPr/>
        </p:nvSpPr>
        <p:spPr>
          <a:xfrm flipH="1">
            <a:off x="2166480" y="1165320"/>
            <a:ext cx="65160" cy="658800"/>
          </a:xfrm>
          <a:prstGeom prst="line">
            <a:avLst/>
          </a:prstGeom>
          <a:ln cap="sq" w="15840">
            <a:solidFill>
              <a:srgbClr val="33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216"/>
          <p:cNvSpPr/>
          <p:nvPr/>
        </p:nvSpPr>
        <p:spPr>
          <a:xfrm rot="16681800">
            <a:off x="2039760" y="879120"/>
            <a:ext cx="438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2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1217"/>
          <p:cNvSpPr/>
          <p:nvPr/>
        </p:nvSpPr>
        <p:spPr>
          <a:xfrm flipH="1">
            <a:off x="2568240" y="1038240"/>
            <a:ext cx="120600" cy="558720"/>
          </a:xfrm>
          <a:prstGeom prst="line">
            <a:avLst/>
          </a:prstGeom>
          <a:ln cap="sq" w="15840">
            <a:solidFill>
              <a:srgbClr val="33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218"/>
          <p:cNvSpPr/>
          <p:nvPr/>
        </p:nvSpPr>
        <p:spPr>
          <a:xfrm rot="17071200">
            <a:off x="2559600" y="801720"/>
            <a:ext cx="354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2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1219"/>
          <p:cNvSpPr/>
          <p:nvPr/>
        </p:nvSpPr>
        <p:spPr>
          <a:xfrm flipH="1">
            <a:off x="2568240" y="1386000"/>
            <a:ext cx="399960" cy="210960"/>
          </a:xfrm>
          <a:prstGeom prst="line">
            <a:avLst/>
          </a:prstGeom>
          <a:ln cap="sq" w="15840">
            <a:solidFill>
              <a:srgbClr val="33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1220"/>
          <p:cNvSpPr/>
          <p:nvPr/>
        </p:nvSpPr>
        <p:spPr>
          <a:xfrm rot="20170800">
            <a:off x="2962800" y="123156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2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1221"/>
          <p:cNvSpPr/>
          <p:nvPr/>
        </p:nvSpPr>
        <p:spPr>
          <a:xfrm flipH="1">
            <a:off x="2166840" y="1596960"/>
            <a:ext cx="401760" cy="227160"/>
          </a:xfrm>
          <a:prstGeom prst="line">
            <a:avLst/>
          </a:prstGeom>
          <a:ln cap="sq" w="15840">
            <a:solidFill>
              <a:srgbClr val="33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1222"/>
          <p:cNvSpPr/>
          <p:nvPr/>
        </p:nvSpPr>
        <p:spPr>
          <a:xfrm flipH="1">
            <a:off x="1750680" y="1824120"/>
            <a:ext cx="415800" cy="495360"/>
          </a:xfrm>
          <a:prstGeom prst="line">
            <a:avLst/>
          </a:prstGeom>
          <a:ln cap="sq" w="15840">
            <a:solidFill>
              <a:srgbClr val="33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1223"/>
          <p:cNvSpPr/>
          <p:nvPr/>
        </p:nvSpPr>
        <p:spPr>
          <a:xfrm flipH="1">
            <a:off x="2278080" y="1819440"/>
            <a:ext cx="860400" cy="42516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224"/>
          <p:cNvSpPr/>
          <p:nvPr/>
        </p:nvSpPr>
        <p:spPr>
          <a:xfrm rot="20421600">
            <a:off x="3144960" y="167760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1225"/>
          <p:cNvSpPr/>
          <p:nvPr/>
        </p:nvSpPr>
        <p:spPr>
          <a:xfrm flipH="1">
            <a:off x="2784240" y="2222640"/>
            <a:ext cx="355320" cy="13968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226"/>
          <p:cNvSpPr/>
          <p:nvPr/>
        </p:nvSpPr>
        <p:spPr>
          <a:xfrm>
            <a:off x="3167280" y="2181240"/>
            <a:ext cx="4824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1227"/>
          <p:cNvSpPr/>
          <p:nvPr/>
        </p:nvSpPr>
        <p:spPr>
          <a:xfrm flipH="1">
            <a:off x="3081240" y="2452680"/>
            <a:ext cx="76320" cy="4284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228"/>
          <p:cNvSpPr/>
          <p:nvPr/>
        </p:nvSpPr>
        <p:spPr>
          <a:xfrm>
            <a:off x="3201480" y="2401920"/>
            <a:ext cx="399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1229"/>
          <p:cNvSpPr/>
          <p:nvPr/>
        </p:nvSpPr>
        <p:spPr>
          <a:xfrm flipH="1" flipV="1">
            <a:off x="3081240" y="2495520"/>
            <a:ext cx="101520" cy="3816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1230"/>
          <p:cNvSpPr/>
          <p:nvPr/>
        </p:nvSpPr>
        <p:spPr>
          <a:xfrm>
            <a:off x="3227040" y="2508120"/>
            <a:ext cx="308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1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231"/>
          <p:cNvSpPr/>
          <p:nvPr/>
        </p:nvSpPr>
        <p:spPr>
          <a:xfrm flipH="1" flipV="1">
            <a:off x="2784600" y="2362320"/>
            <a:ext cx="296640" cy="13320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1232"/>
          <p:cNvSpPr/>
          <p:nvPr/>
        </p:nvSpPr>
        <p:spPr>
          <a:xfrm flipH="1" flipV="1">
            <a:off x="2277720" y="2244240"/>
            <a:ext cx="506520" cy="11772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1233"/>
          <p:cNvSpPr/>
          <p:nvPr/>
        </p:nvSpPr>
        <p:spPr>
          <a:xfrm flipH="1">
            <a:off x="1751040" y="2244600"/>
            <a:ext cx="527040" cy="74880"/>
          </a:xfrm>
          <a:prstGeom prst="line">
            <a:avLst/>
          </a:prstGeom>
          <a:ln cap="sq" w="158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1234"/>
          <p:cNvSpPr/>
          <p:nvPr/>
        </p:nvSpPr>
        <p:spPr>
          <a:xfrm flipH="1">
            <a:off x="1378080" y="2319480"/>
            <a:ext cx="372960" cy="27936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1235"/>
          <p:cNvSpPr/>
          <p:nvPr/>
        </p:nvSpPr>
        <p:spPr>
          <a:xfrm flipH="1" flipV="1">
            <a:off x="1884240" y="2695680"/>
            <a:ext cx="741600" cy="6336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236"/>
          <p:cNvSpPr/>
          <p:nvPr/>
        </p:nvSpPr>
        <p:spPr>
          <a:xfrm>
            <a:off x="2669400" y="271944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1237"/>
          <p:cNvSpPr/>
          <p:nvPr/>
        </p:nvSpPr>
        <p:spPr>
          <a:xfrm flipH="1">
            <a:off x="2172960" y="2930400"/>
            <a:ext cx="717480" cy="14292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238"/>
          <p:cNvSpPr/>
          <p:nvPr/>
        </p:nvSpPr>
        <p:spPr>
          <a:xfrm>
            <a:off x="2925000" y="2887560"/>
            <a:ext cx="354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2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1239"/>
          <p:cNvSpPr/>
          <p:nvPr/>
        </p:nvSpPr>
        <p:spPr>
          <a:xfrm flipH="1">
            <a:off x="2971440" y="3105000"/>
            <a:ext cx="214200" cy="13680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240"/>
          <p:cNvSpPr/>
          <p:nvPr/>
        </p:nvSpPr>
        <p:spPr>
          <a:xfrm>
            <a:off x="3210840" y="3059280"/>
            <a:ext cx="442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Goldfish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241"/>
          <p:cNvSpPr/>
          <p:nvPr/>
        </p:nvSpPr>
        <p:spPr>
          <a:xfrm flipH="1" flipV="1">
            <a:off x="2971440" y="3241440"/>
            <a:ext cx="320760" cy="5076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1242"/>
          <p:cNvSpPr/>
          <p:nvPr/>
        </p:nvSpPr>
        <p:spPr>
          <a:xfrm>
            <a:off x="3325680" y="3257640"/>
            <a:ext cx="474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1243"/>
          <p:cNvSpPr/>
          <p:nvPr/>
        </p:nvSpPr>
        <p:spPr>
          <a:xfrm flipH="1">
            <a:off x="2457000" y="3241800"/>
            <a:ext cx="514440" cy="13320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244"/>
          <p:cNvSpPr/>
          <p:nvPr/>
        </p:nvSpPr>
        <p:spPr>
          <a:xfrm flipH="1">
            <a:off x="2730240" y="3591000"/>
            <a:ext cx="547560" cy="2232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1245"/>
          <p:cNvSpPr/>
          <p:nvPr/>
        </p:nvSpPr>
        <p:spPr>
          <a:xfrm>
            <a:off x="3321360" y="3552840"/>
            <a:ext cx="601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inbow trout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1246"/>
          <p:cNvSpPr/>
          <p:nvPr/>
        </p:nvSpPr>
        <p:spPr>
          <a:xfrm flipH="1">
            <a:off x="3020760" y="4013280"/>
            <a:ext cx="569880" cy="8244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1247"/>
          <p:cNvSpPr/>
          <p:nvPr/>
        </p:nvSpPr>
        <p:spPr>
          <a:xfrm>
            <a:off x="3624840" y="3971880"/>
            <a:ext cx="354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1248"/>
          <p:cNvSpPr/>
          <p:nvPr/>
        </p:nvSpPr>
        <p:spPr>
          <a:xfrm flipH="1" flipV="1">
            <a:off x="3021120" y="4095720"/>
            <a:ext cx="390240" cy="41112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1249"/>
          <p:cNvSpPr/>
          <p:nvPr/>
        </p:nvSpPr>
        <p:spPr>
          <a:xfrm>
            <a:off x="3454200" y="4470480"/>
            <a:ext cx="730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Japanese flounder TLR2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1250"/>
          <p:cNvSpPr/>
          <p:nvPr/>
        </p:nvSpPr>
        <p:spPr>
          <a:xfrm flipH="1" flipV="1">
            <a:off x="2730240" y="3613320"/>
            <a:ext cx="290520" cy="48240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1251"/>
          <p:cNvSpPr/>
          <p:nvPr/>
        </p:nvSpPr>
        <p:spPr>
          <a:xfrm flipH="1" flipV="1">
            <a:off x="2457000" y="3375000"/>
            <a:ext cx="273240" cy="23832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1252"/>
          <p:cNvSpPr/>
          <p:nvPr/>
        </p:nvSpPr>
        <p:spPr>
          <a:xfrm flipH="1" flipV="1">
            <a:off x="2172960" y="3073320"/>
            <a:ext cx="284040" cy="30168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1253"/>
          <p:cNvSpPr/>
          <p:nvPr/>
        </p:nvSpPr>
        <p:spPr>
          <a:xfrm flipH="1" flipV="1">
            <a:off x="1883880" y="2695320"/>
            <a:ext cx="289080" cy="37764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1254"/>
          <p:cNvSpPr/>
          <p:nvPr/>
        </p:nvSpPr>
        <p:spPr>
          <a:xfrm flipH="1" flipV="1">
            <a:off x="1378080" y="2598480"/>
            <a:ext cx="506160" cy="96840"/>
          </a:xfrm>
          <a:prstGeom prst="line">
            <a:avLst/>
          </a:prstGeom>
          <a:ln cap="sq" w="158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1255"/>
          <p:cNvSpPr/>
          <p:nvPr/>
        </p:nvSpPr>
        <p:spPr>
          <a:xfrm flipH="1">
            <a:off x="761760" y="2598840"/>
            <a:ext cx="615960" cy="21888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1256"/>
          <p:cNvSpPr/>
          <p:nvPr/>
        </p:nvSpPr>
        <p:spPr>
          <a:xfrm flipH="1">
            <a:off x="541080" y="2832120"/>
            <a:ext cx="214200" cy="37476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1257"/>
          <p:cNvSpPr/>
          <p:nvPr/>
        </p:nvSpPr>
        <p:spPr>
          <a:xfrm>
            <a:off x="2020680" y="1768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258"/>
          <p:cNvSpPr/>
          <p:nvPr/>
        </p:nvSpPr>
        <p:spPr>
          <a:xfrm>
            <a:off x="2474640" y="15098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5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1259"/>
          <p:cNvSpPr/>
          <p:nvPr/>
        </p:nvSpPr>
        <p:spPr>
          <a:xfrm>
            <a:off x="2955600" y="24922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1260"/>
          <p:cNvSpPr/>
          <p:nvPr/>
        </p:nvSpPr>
        <p:spPr>
          <a:xfrm>
            <a:off x="2668320" y="23652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1261"/>
          <p:cNvSpPr/>
          <p:nvPr/>
        </p:nvSpPr>
        <p:spPr>
          <a:xfrm>
            <a:off x="2196720" y="22575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1262"/>
          <p:cNvSpPr/>
          <p:nvPr/>
        </p:nvSpPr>
        <p:spPr>
          <a:xfrm>
            <a:off x="1679040" y="22417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1263"/>
          <p:cNvSpPr/>
          <p:nvPr/>
        </p:nvSpPr>
        <p:spPr>
          <a:xfrm>
            <a:off x="947520" y="4827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1264"/>
          <p:cNvSpPr/>
          <p:nvPr/>
        </p:nvSpPr>
        <p:spPr>
          <a:xfrm>
            <a:off x="731520" y="7556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1265"/>
          <p:cNvSpPr/>
          <p:nvPr/>
        </p:nvSpPr>
        <p:spPr>
          <a:xfrm>
            <a:off x="650520" y="11001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1266"/>
          <p:cNvSpPr/>
          <p:nvPr/>
        </p:nvSpPr>
        <p:spPr>
          <a:xfrm>
            <a:off x="1204560" y="8827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1267"/>
          <p:cNvSpPr/>
          <p:nvPr/>
        </p:nvSpPr>
        <p:spPr>
          <a:xfrm>
            <a:off x="844200" y="14749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1268"/>
          <p:cNvSpPr/>
          <p:nvPr/>
        </p:nvSpPr>
        <p:spPr>
          <a:xfrm>
            <a:off x="931680" y="22068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269"/>
          <p:cNvSpPr/>
          <p:nvPr/>
        </p:nvSpPr>
        <p:spPr>
          <a:xfrm>
            <a:off x="2914200" y="32529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1270"/>
          <p:cNvSpPr/>
          <p:nvPr/>
        </p:nvSpPr>
        <p:spPr>
          <a:xfrm>
            <a:off x="2376000" y="33544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271"/>
          <p:cNvSpPr/>
          <p:nvPr/>
        </p:nvSpPr>
        <p:spPr>
          <a:xfrm>
            <a:off x="2612520" y="35989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1272"/>
          <p:cNvSpPr/>
          <p:nvPr/>
        </p:nvSpPr>
        <p:spPr>
          <a:xfrm>
            <a:off x="2095200" y="30718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1273"/>
          <p:cNvSpPr/>
          <p:nvPr/>
        </p:nvSpPr>
        <p:spPr>
          <a:xfrm>
            <a:off x="1815840" y="26989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1274"/>
          <p:cNvSpPr/>
          <p:nvPr/>
        </p:nvSpPr>
        <p:spPr>
          <a:xfrm>
            <a:off x="1333080" y="26067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8T11:27:04Z</dcterms:created>
  <dc:creator>Nicholas David Temperley</dc:creator>
  <dc:description/>
  <dc:language>en-US</dc:language>
  <cp:lastModifiedBy>Nicholas David Temperley</cp:lastModifiedBy>
  <dcterms:modified xsi:type="dcterms:W3CDTF">2008-01-31T15:39:23Z</dcterms:modified>
  <cp:revision>41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1053461356</vt:r8>
  </property>
</Properties>
</file>